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altLang="zh-HK" sz="3200" b="1" dirty="0">
                <a:solidFill>
                  <a:schemeClr val="bg1"/>
                </a:solidFill>
              </a:rPr>
              <a:t>Childhood idiopathic nephrotic syndrome: </a:t>
            </a:r>
            <a:br>
              <a:rPr lang="en-GB" altLang="zh-HK" sz="3200" b="1" dirty="0">
                <a:solidFill>
                  <a:schemeClr val="bg1"/>
                </a:solidFill>
              </a:rPr>
            </a:br>
            <a:r>
              <a:rPr lang="en-GB" altLang="zh-HK" sz="3200" b="1" dirty="0">
                <a:solidFill>
                  <a:schemeClr val="bg1"/>
                </a:solidFill>
              </a:rPr>
              <a:t>recent advancements shaping future guidelines</a:t>
            </a:r>
            <a:endParaRPr lang="zh-TW" altLang="zh-HK" sz="3200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70649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This review summarises new developments in:</a:t>
            </a:r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han &amp; Boyer,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: </a:t>
            </a:r>
            <a:r>
              <a:rPr lang="en-GB" dirty="0">
                <a:solidFill>
                  <a:schemeClr val="bg1"/>
                </a:solidFill>
              </a:rPr>
              <a:t>There are </a:t>
            </a:r>
            <a:r>
              <a:rPr lang="en-GB" altLang="zh-HK" dirty="0">
                <a:solidFill>
                  <a:schemeClr val="bg1"/>
                </a:solidFill>
              </a:rPr>
              <a:t>significant advances in understanding pathogenesis and optimizing treatments since the consensus guidelines. These findings may constitute important implications in revising future recommendation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AFA2043-60B8-7E0E-CBA1-2FD6121EA4B4}"/>
              </a:ext>
            </a:extLst>
          </p:cNvPr>
          <p:cNvSpPr txBox="1"/>
          <p:nvPr/>
        </p:nvSpPr>
        <p:spPr>
          <a:xfrm>
            <a:off x="239282" y="1694990"/>
            <a:ext cx="22944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2400" b="1" dirty="0">
                <a:solidFill>
                  <a:schemeClr val="accent2">
                    <a:lumMod val="75000"/>
                  </a:schemeClr>
                </a:solidFill>
              </a:rPr>
              <a:t>NS pathogenesi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B61A69C-AD61-DFCD-9F99-7E7060AA13B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889"/>
          <a:stretch/>
        </p:blipFill>
        <p:spPr>
          <a:xfrm>
            <a:off x="489113" y="4407127"/>
            <a:ext cx="1119402" cy="94153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A1F0014-616F-520D-C8C3-B7CF1C3F2E1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920"/>
          <a:stretch/>
        </p:blipFill>
        <p:spPr>
          <a:xfrm>
            <a:off x="389335" y="3146044"/>
            <a:ext cx="1294527" cy="106255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8B2225B-70B2-0B9E-0B92-EBEAA7ED93E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557"/>
          <a:stretch/>
        </p:blipFill>
        <p:spPr>
          <a:xfrm>
            <a:off x="542705" y="2309175"/>
            <a:ext cx="987788" cy="82423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F7DD428-6C96-A5A2-DEA9-2679A1A9FEB1}"/>
              </a:ext>
            </a:extLst>
          </p:cNvPr>
          <p:cNvSpPr txBox="1"/>
          <p:nvPr/>
        </p:nvSpPr>
        <p:spPr>
          <a:xfrm>
            <a:off x="1608515" y="2416570"/>
            <a:ext cx="21031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600" dirty="0"/>
              <a:t>Anti-</a:t>
            </a:r>
            <a:r>
              <a:rPr lang="en-US" altLang="zh-HK" sz="1600" dirty="0" err="1"/>
              <a:t>nephrin</a:t>
            </a:r>
            <a:r>
              <a:rPr lang="en-US" altLang="zh-HK" sz="1600" dirty="0"/>
              <a:t> and other</a:t>
            </a:r>
            <a:br>
              <a:rPr lang="en-US" altLang="zh-HK" sz="1600" dirty="0"/>
            </a:br>
            <a:r>
              <a:rPr lang="en-US" altLang="zh-HK" sz="1600" dirty="0"/>
              <a:t>auto-antibodies</a:t>
            </a:r>
            <a:endParaRPr lang="zh-HK" altLang="en-US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F49919D-60B1-0284-1D53-0768BCC9E23A}"/>
              </a:ext>
            </a:extLst>
          </p:cNvPr>
          <p:cNvSpPr txBox="1"/>
          <p:nvPr/>
        </p:nvSpPr>
        <p:spPr>
          <a:xfrm>
            <a:off x="1608515" y="3354155"/>
            <a:ext cx="25789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600" dirty="0"/>
              <a:t>B and T cells</a:t>
            </a:r>
          </a:p>
          <a:p>
            <a:r>
              <a:rPr lang="en-US" altLang="zh-HK" sz="1600" dirty="0"/>
              <a:t>(Memory B cell subsets and regulatory T cells)</a:t>
            </a:r>
            <a:endParaRPr lang="zh-HK" altLang="en-US" sz="16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07A1D4E-D906-0093-23D9-731A2D1047B9}"/>
              </a:ext>
            </a:extLst>
          </p:cNvPr>
          <p:cNvSpPr txBox="1"/>
          <p:nvPr/>
        </p:nvSpPr>
        <p:spPr>
          <a:xfrm>
            <a:off x="1631511" y="4446126"/>
            <a:ext cx="257892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600" dirty="0"/>
              <a:t>SNPs in genes encoding</a:t>
            </a:r>
            <a:br>
              <a:rPr lang="en-US" altLang="zh-HK" sz="1600" dirty="0"/>
            </a:br>
            <a:r>
              <a:rPr lang="en-US" altLang="zh-HK" sz="1600" dirty="0"/>
              <a:t>immune system and </a:t>
            </a:r>
            <a:br>
              <a:rPr lang="en-US" altLang="zh-HK" sz="1600" dirty="0"/>
            </a:br>
            <a:r>
              <a:rPr lang="en-US" altLang="zh-HK" sz="1600" dirty="0"/>
              <a:t>kidney structural proteins associated with SSNS</a:t>
            </a:r>
            <a:endParaRPr lang="zh-HK" altLang="en-US" sz="16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9C3038-4DFC-1218-BC32-09BDBFFD9D84}"/>
              </a:ext>
            </a:extLst>
          </p:cNvPr>
          <p:cNvSpPr txBox="1"/>
          <p:nvPr/>
        </p:nvSpPr>
        <p:spPr>
          <a:xfrm>
            <a:off x="4266843" y="1694990"/>
            <a:ext cx="8242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2400" b="1" dirty="0">
                <a:solidFill>
                  <a:schemeClr val="accent2">
                    <a:lumMod val="75000"/>
                  </a:schemeClr>
                </a:solidFill>
              </a:rPr>
              <a:t>SSNS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1696795-57C5-B316-9367-B416E0B1E1F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24" b="13036"/>
          <a:stretch/>
        </p:blipFill>
        <p:spPr>
          <a:xfrm>
            <a:off x="4547520" y="2231729"/>
            <a:ext cx="571692" cy="5218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0A3BECC-1492-D971-B8CB-146DBD66A42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215"/>
          <a:stretch/>
        </p:blipFill>
        <p:spPr>
          <a:xfrm>
            <a:off x="4387365" y="2798915"/>
            <a:ext cx="892003" cy="56004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42A7761-FC34-E9A4-3AE1-A887FB31535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732"/>
          <a:stretch/>
        </p:blipFill>
        <p:spPr>
          <a:xfrm>
            <a:off x="4518304" y="3552055"/>
            <a:ext cx="732799" cy="62483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C82551A-5A7C-0E68-53F9-98C4E1AFE2A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822"/>
          <a:stretch/>
        </p:blipFill>
        <p:spPr>
          <a:xfrm rot="18000000">
            <a:off x="4459768" y="4909826"/>
            <a:ext cx="817936" cy="63944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CB74C498-BA56-6026-6783-47E1AF40E4D0}"/>
              </a:ext>
            </a:extLst>
          </p:cNvPr>
          <p:cNvSpPr txBox="1"/>
          <p:nvPr/>
        </p:nvSpPr>
        <p:spPr>
          <a:xfrm>
            <a:off x="5251103" y="2200248"/>
            <a:ext cx="21568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600" dirty="0"/>
              <a:t>Combination therapy at</a:t>
            </a:r>
            <a:br>
              <a:rPr lang="en-US" altLang="zh-HK" sz="1600" dirty="0"/>
            </a:br>
            <a:r>
              <a:rPr lang="en-US" altLang="zh-HK" sz="1600" dirty="0"/>
              <a:t>first presentation </a:t>
            </a:r>
            <a:endParaRPr lang="zh-HK" altLang="en-US" sz="16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02F0D5-C1CE-FD0B-C512-429AA9E4E4D2}"/>
              </a:ext>
            </a:extLst>
          </p:cNvPr>
          <p:cNvSpPr txBox="1"/>
          <p:nvPr/>
        </p:nvSpPr>
        <p:spPr>
          <a:xfrm>
            <a:off x="5251103" y="3006856"/>
            <a:ext cx="1790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600" dirty="0"/>
              <a:t>Levamisole in FRNS</a:t>
            </a:r>
            <a:endParaRPr lang="zh-HK" altLang="en-US" sz="16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60715E1-09D7-6AE2-F77A-15432A37E6C1}"/>
              </a:ext>
            </a:extLst>
          </p:cNvPr>
          <p:cNvSpPr txBox="1"/>
          <p:nvPr/>
        </p:nvSpPr>
        <p:spPr>
          <a:xfrm>
            <a:off x="5279368" y="3448975"/>
            <a:ext cx="2689069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600" dirty="0"/>
              <a:t>Rituximab schedule</a:t>
            </a:r>
          </a:p>
          <a:p>
            <a:r>
              <a:rPr lang="en-GB" sz="1600" dirty="0"/>
              <a:t>Rituximab followed by MMF</a:t>
            </a:r>
            <a:endParaRPr lang="en-US" altLang="zh-HK" sz="1600" dirty="0"/>
          </a:p>
          <a:p>
            <a:r>
              <a:rPr lang="en-US" altLang="zh-HK" sz="1600" dirty="0" err="1"/>
              <a:t>Obinutuzumab</a:t>
            </a:r>
            <a:endParaRPr lang="en-US" altLang="zh-HK" sz="1600" dirty="0"/>
          </a:p>
          <a:p>
            <a:endParaRPr lang="en-US" altLang="zh-HK" sz="2400" dirty="0"/>
          </a:p>
          <a:p>
            <a:r>
              <a:rPr lang="en-US" altLang="zh-HK" sz="1600" dirty="0"/>
              <a:t>Memory B-cells as biomarke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9319C82-8338-F2A5-CFB6-9CF2A41AEEBD}"/>
              </a:ext>
            </a:extLst>
          </p:cNvPr>
          <p:cNvSpPr txBox="1"/>
          <p:nvPr/>
        </p:nvSpPr>
        <p:spPr>
          <a:xfrm>
            <a:off x="5279368" y="4692347"/>
            <a:ext cx="261443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altLang="zh-HK" sz="1600" dirty="0"/>
          </a:p>
          <a:p>
            <a:endParaRPr lang="en-US" altLang="zh-HK" sz="1600" dirty="0"/>
          </a:p>
          <a:p>
            <a:r>
              <a:rPr lang="en-US" altLang="zh-HK" sz="1600" dirty="0"/>
              <a:t>Hypo IgG risk and monitoring</a:t>
            </a:r>
            <a:endParaRPr lang="zh-HK" altLang="en-US" sz="16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FAF2F21-7DFA-D8D2-CFCC-187E1579A836}"/>
              </a:ext>
            </a:extLst>
          </p:cNvPr>
          <p:cNvSpPr txBox="1"/>
          <p:nvPr/>
        </p:nvSpPr>
        <p:spPr>
          <a:xfrm>
            <a:off x="8179393" y="1689559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2400" b="1" dirty="0">
                <a:solidFill>
                  <a:schemeClr val="accent2">
                    <a:lumMod val="75000"/>
                  </a:schemeClr>
                </a:solidFill>
              </a:rPr>
              <a:t>SRNS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54A642C-3349-E572-BBB2-C4E40C4580D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581"/>
          <a:stretch/>
        </p:blipFill>
        <p:spPr>
          <a:xfrm>
            <a:off x="8179393" y="2200248"/>
            <a:ext cx="911706" cy="77877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AE249980-C496-93A9-A8F0-4AAC0AEF781B}"/>
              </a:ext>
            </a:extLst>
          </p:cNvPr>
          <p:cNvSpPr txBox="1"/>
          <p:nvPr/>
        </p:nvSpPr>
        <p:spPr>
          <a:xfrm>
            <a:off x="9030908" y="2099106"/>
            <a:ext cx="3088286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600" b="1" dirty="0">
                <a:solidFill>
                  <a:srgbClr val="860050"/>
                </a:solidFill>
              </a:rPr>
              <a:t>Monogenic SRNS</a:t>
            </a:r>
            <a:endParaRPr lang="en-US" altLang="zh-HK" sz="1600" dirty="0"/>
          </a:p>
          <a:p>
            <a:pPr marL="142875" indent="-133350"/>
            <a:endParaRPr lang="en-US" altLang="zh-HK" sz="1000" dirty="0"/>
          </a:p>
          <a:p>
            <a:pPr marL="142875" indent="-133350"/>
            <a:r>
              <a:rPr lang="en-US" altLang="zh-HK" sz="1600" dirty="0"/>
              <a:t>CNIs as anti-</a:t>
            </a:r>
            <a:r>
              <a:rPr lang="en-US" altLang="zh-HK" sz="1600" dirty="0" err="1"/>
              <a:t>proteinuric</a:t>
            </a:r>
            <a:r>
              <a:rPr lang="en-US" altLang="zh-HK" sz="1600" dirty="0"/>
              <a:t> therapy in selected children</a:t>
            </a:r>
          </a:p>
          <a:p>
            <a:pPr marL="142875" indent="-133350"/>
            <a:r>
              <a:rPr lang="en-US" altLang="zh-HK" sz="1600" dirty="0"/>
              <a:t>Coenzyme Q10 deficiency and supplementation</a:t>
            </a:r>
            <a:endParaRPr lang="zh-HK" altLang="en-US" sz="1600" dirty="0"/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D3B56D9E-86EF-E86B-327C-CE581ADB84FE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794"/>
          <a:stretch/>
        </p:blipFill>
        <p:spPr>
          <a:xfrm>
            <a:off x="8160221" y="3784231"/>
            <a:ext cx="943266" cy="803723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7526364A-D3C2-7EE8-99A5-52F3C782C344}"/>
              </a:ext>
            </a:extLst>
          </p:cNvPr>
          <p:cNvSpPr txBox="1"/>
          <p:nvPr/>
        </p:nvSpPr>
        <p:spPr>
          <a:xfrm>
            <a:off x="9030908" y="3784406"/>
            <a:ext cx="3161093" cy="17389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600" b="1" dirty="0" err="1">
                <a:solidFill>
                  <a:srgbClr val="860050"/>
                </a:solidFill>
              </a:rPr>
              <a:t>Dysimmune</a:t>
            </a:r>
            <a:r>
              <a:rPr lang="en-US" altLang="zh-HK" sz="1600" b="1" dirty="0">
                <a:solidFill>
                  <a:srgbClr val="860050"/>
                </a:solidFill>
              </a:rPr>
              <a:t> SRNS</a:t>
            </a:r>
          </a:p>
          <a:p>
            <a:endParaRPr lang="en-US" altLang="zh-HK" sz="1000" dirty="0"/>
          </a:p>
          <a:p>
            <a:r>
              <a:rPr lang="en-US" altLang="zh-HK" sz="1600" dirty="0"/>
              <a:t>Rituximab in CNI-resistant SRNS</a:t>
            </a:r>
          </a:p>
          <a:p>
            <a:pPr marL="92075" indent="-92075"/>
            <a:r>
              <a:rPr lang="en-US" altLang="zh-HK" sz="1600" dirty="0"/>
              <a:t>Rituximab and Daratumumab in multi-drug resistant NS</a:t>
            </a:r>
          </a:p>
          <a:p>
            <a:pPr marL="92075" indent="-92075"/>
            <a:r>
              <a:rPr lang="en-US" altLang="zh-HK" sz="1600" dirty="0"/>
              <a:t>Rituximab and Immunoadsorption + IVIG in SRNS</a:t>
            </a:r>
          </a:p>
        </p:txBody>
      </p:sp>
      <p:pic>
        <p:nvPicPr>
          <p:cNvPr id="29" name="Picture 3">
            <a:extLst>
              <a:ext uri="{FF2B5EF4-FFF2-40B4-BE49-F238E27FC236}">
                <a16:creationId xmlns:a16="http://schemas.microsoft.com/office/drawing/2014/main" id="{440C5A6D-3B86-0497-E20D-DD986407E8C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920"/>
          <a:stretch/>
        </p:blipFill>
        <p:spPr>
          <a:xfrm>
            <a:off x="4387365" y="4228802"/>
            <a:ext cx="860865" cy="706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5</TotalTime>
  <Words>150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12-10T17:31:40Z</dcterms:modified>
</cp:coreProperties>
</file>